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8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ave Reiner" initials="DR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00000"/>
    <a:srgbClr val="829FC6"/>
    <a:srgbClr val="D5A6A8"/>
    <a:srgbClr val="BB6A6B"/>
    <a:srgbClr val="A23739"/>
    <a:srgbClr val="842B2E"/>
    <a:srgbClr val="54647B"/>
    <a:srgbClr val="435061"/>
    <a:srgbClr val="379D51"/>
    <a:srgbClr val="87A2C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61" autoAdjust="0"/>
    <p:restoredTop sz="95900" autoAdjust="0"/>
  </p:normalViewPr>
  <p:slideViewPr>
    <p:cSldViewPr snapToGrid="0" snapToObjects="1">
      <p:cViewPr varScale="1">
        <p:scale>
          <a:sx n="119" d="100"/>
          <a:sy n="119" d="100"/>
        </p:scale>
        <p:origin x="744" y="17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dreiner:Desktop:unc-54r293_11-2011_totals%20DR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7590726159230103E-2"/>
          <c:y val="0.140610055322032"/>
          <c:w val="0.91917707786526703"/>
          <c:h val="0.82228879284826195"/>
        </c:manualLayout>
      </c:layout>
      <c:barChart>
        <c:barDir val="col"/>
        <c:grouping val="clustered"/>
        <c:varyColors val="0"/>
        <c:ser>
          <c:idx val="0"/>
          <c:order val="0"/>
          <c:tx>
            <c:v>15C</c:v>
          </c:tx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(Composite!$C$31,Composite!$F$31,Composite!$I$31,Composite!$L$31,Composite!$O$31,Composite!$R$31,Composite!$U$31,Composite!$U$31,Composite!$C$10,Composite!$F$10,Composite!$I$10,Composite!$L$10,Composite!$O$10,Composite!$R$10)</c:f>
                <c:numCache>
                  <c:formatCode>General</c:formatCode>
                  <c:ptCount val="14"/>
                  <c:pt idx="0">
                    <c:v>0.88500000000000001</c:v>
                  </c:pt>
                  <c:pt idx="1">
                    <c:v>0.251</c:v>
                  </c:pt>
                  <c:pt idx="2">
                    <c:v>0.24399999999999999</c:v>
                  </c:pt>
                  <c:pt idx="3">
                    <c:v>0.221</c:v>
                  </c:pt>
                  <c:pt idx="4">
                    <c:v>0.80500000000000005</c:v>
                  </c:pt>
                  <c:pt idx="5">
                    <c:v>0.91900000000000004</c:v>
                  </c:pt>
                  <c:pt idx="8">
                    <c:v>1.046</c:v>
                  </c:pt>
                  <c:pt idx="9">
                    <c:v>0.17199999999999999</c:v>
                  </c:pt>
                  <c:pt idx="10">
                    <c:v>0.84199999999999997</c:v>
                  </c:pt>
                  <c:pt idx="11">
                    <c:v>0.89400000000000002</c:v>
                  </c:pt>
                  <c:pt idx="12">
                    <c:v>0.876</c:v>
                  </c:pt>
                  <c:pt idx="13">
                    <c:v>0.73399999999999999</c:v>
                  </c:pt>
                </c:numCache>
              </c:numRef>
            </c:plus>
            <c:minus>
              <c:numRef>
                <c:f>(Composite!$C$31,Composite!$F$31,Composite!$I$31,Composite!$L$31,Composite!$O$31,Composite!$R$31,Composite!$U$31,Composite!$U$31,Composite!$C$10,Composite!$F$10,Composite!$I$10,Composite!$L$10,Composite!$O$10,Composite!$R$10)</c:f>
                <c:numCache>
                  <c:formatCode>General</c:formatCode>
                  <c:ptCount val="14"/>
                  <c:pt idx="0">
                    <c:v>0.88500000000000001</c:v>
                  </c:pt>
                  <c:pt idx="1">
                    <c:v>0.251</c:v>
                  </c:pt>
                  <c:pt idx="2">
                    <c:v>0.24399999999999999</c:v>
                  </c:pt>
                  <c:pt idx="3">
                    <c:v>0.221</c:v>
                  </c:pt>
                  <c:pt idx="4">
                    <c:v>0.80500000000000005</c:v>
                  </c:pt>
                  <c:pt idx="5">
                    <c:v>0.91900000000000004</c:v>
                  </c:pt>
                  <c:pt idx="8">
                    <c:v>1.046</c:v>
                  </c:pt>
                  <c:pt idx="9">
                    <c:v>0.17199999999999999</c:v>
                  </c:pt>
                  <c:pt idx="10">
                    <c:v>0.84199999999999997</c:v>
                  </c:pt>
                  <c:pt idx="11">
                    <c:v>0.89400000000000002</c:v>
                  </c:pt>
                  <c:pt idx="12">
                    <c:v>0.876</c:v>
                  </c:pt>
                  <c:pt idx="13">
                    <c:v>0.73399999999999999</c:v>
                  </c:pt>
                </c:numCache>
              </c:numRef>
            </c:minus>
            <c:spPr>
              <a:ln w="28575">
                <a:solidFill>
                  <a:sysClr val="windowText" lastClr="000000"/>
                </a:solidFill>
              </a:ln>
            </c:spPr>
          </c:errBars>
          <c:val>
            <c:numRef>
              <c:f>(Composite!$C$30,Composite!$F$30,Composite!$I$30,Composite!$L$30,Composite!$O$30,Composite!$R$30,Composite!$T$30,Composite!$T$30,Composite!$C$9,Composite!$F$9,Composite!$I$9,Composite!$L$9,Composite!$O$9,Composite!$R$9)</c:f>
              <c:numCache>
                <c:formatCode>General</c:formatCode>
                <c:ptCount val="14"/>
                <c:pt idx="0">
                  <c:v>6.3150684931506902</c:v>
                </c:pt>
                <c:pt idx="1">
                  <c:v>2.493150684931507</c:v>
                </c:pt>
                <c:pt idx="2">
                  <c:v>1.9657142857142851</c:v>
                </c:pt>
                <c:pt idx="3">
                  <c:v>2.3840579710144931</c:v>
                </c:pt>
                <c:pt idx="4">
                  <c:v>7.2361111111111098</c:v>
                </c:pt>
                <c:pt idx="5">
                  <c:v>7.5144927536231876</c:v>
                </c:pt>
                <c:pt idx="8">
                  <c:v>12.36153846153846</c:v>
                </c:pt>
                <c:pt idx="9">
                  <c:v>0.79710144927536197</c:v>
                </c:pt>
                <c:pt idx="10">
                  <c:v>8.1439393939393945</c:v>
                </c:pt>
                <c:pt idx="11">
                  <c:v>9.2898550724637676</c:v>
                </c:pt>
                <c:pt idx="12">
                  <c:v>8.2187499999999982</c:v>
                </c:pt>
                <c:pt idx="13">
                  <c:v>7.57638888888889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A62-4143-9529-0702D83FD2C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0"/>
        <c:overlap val="100"/>
        <c:axId val="-1624137760"/>
        <c:axId val="-1624135440"/>
      </c:barChart>
      <c:catAx>
        <c:axId val="-1624137760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ln w="31750">
            <a:solidFill>
              <a:sysClr val="windowText" lastClr="000000"/>
            </a:solidFill>
          </a:ln>
        </c:spPr>
        <c:crossAx val="-1624135440"/>
        <c:crosses val="autoZero"/>
        <c:auto val="1"/>
        <c:lblAlgn val="ctr"/>
        <c:lblOffset val="100"/>
        <c:noMultiLvlLbl val="0"/>
      </c:catAx>
      <c:valAx>
        <c:axId val="-16241354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31750">
            <a:solidFill>
              <a:sysClr val="windowText" lastClr="000000"/>
            </a:solidFill>
          </a:ln>
        </c:spPr>
        <c:crossAx val="-1624137760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7FE6614-ACFD-1A4E-84EA-CCC941037853}" type="datetimeFigureOut">
              <a:rPr lang="en-US" smtClean="0"/>
              <a:t>7/2/21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7153C66-FF18-934A-B879-113FDC330D8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145301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i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7153C66-FF18-934A-B879-113FDC330D85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930141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24518-3EE8-C442-9B7E-EA4E6F93DF3C}" type="datetimeFigureOut">
              <a:rPr lang="en-US" smtClean="0"/>
              <a:t>7/2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9D9C3-2DB9-CE42-B257-6216D76BAC5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914206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24518-3EE8-C442-9B7E-EA4E6F93DF3C}" type="datetimeFigureOut">
              <a:rPr lang="en-US" smtClean="0"/>
              <a:t>7/2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9D9C3-2DB9-CE42-B257-6216D76BAC5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226145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24518-3EE8-C442-9B7E-EA4E6F93DF3C}" type="datetimeFigureOut">
              <a:rPr lang="en-US" smtClean="0"/>
              <a:t>7/2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9D9C3-2DB9-CE42-B257-6216D76BAC5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307133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24518-3EE8-C442-9B7E-EA4E6F93DF3C}" type="datetimeFigureOut">
              <a:rPr lang="en-US" smtClean="0"/>
              <a:t>7/2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9D9C3-2DB9-CE42-B257-6216D76BAC5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831169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24518-3EE8-C442-9B7E-EA4E6F93DF3C}" type="datetimeFigureOut">
              <a:rPr lang="en-US" smtClean="0"/>
              <a:t>7/2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9D9C3-2DB9-CE42-B257-6216D76BAC5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676052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24518-3EE8-C442-9B7E-EA4E6F93DF3C}" type="datetimeFigureOut">
              <a:rPr lang="en-US" smtClean="0"/>
              <a:t>7/2/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9D9C3-2DB9-CE42-B257-6216D76BAC5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534767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24518-3EE8-C442-9B7E-EA4E6F93DF3C}" type="datetimeFigureOut">
              <a:rPr lang="en-US" smtClean="0"/>
              <a:t>7/2/21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9D9C3-2DB9-CE42-B257-6216D76BAC5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429980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24518-3EE8-C442-9B7E-EA4E6F93DF3C}" type="datetimeFigureOut">
              <a:rPr lang="en-US" smtClean="0"/>
              <a:t>7/2/21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9D9C3-2DB9-CE42-B257-6216D76BAC5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988177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24518-3EE8-C442-9B7E-EA4E6F93DF3C}" type="datetimeFigureOut">
              <a:rPr lang="en-US" smtClean="0"/>
              <a:t>7/2/21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9D9C3-2DB9-CE42-B257-6216D76BAC5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792231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24518-3EE8-C442-9B7E-EA4E6F93DF3C}" type="datetimeFigureOut">
              <a:rPr lang="en-US" smtClean="0"/>
              <a:t>7/2/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9D9C3-2DB9-CE42-B257-6216D76BAC5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036797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24518-3EE8-C442-9B7E-EA4E6F93DF3C}" type="datetimeFigureOut">
              <a:rPr lang="en-US" smtClean="0"/>
              <a:t>7/2/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9D9C3-2DB9-CE42-B257-6216D76BAC5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046548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024518-3EE8-C442-9B7E-EA4E6F93DF3C}" type="datetimeFigureOut">
              <a:rPr lang="en-US" smtClean="0"/>
              <a:t>7/2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29D9C3-2DB9-CE42-B257-6216D76BAC5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800152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616E7BDE-8721-3E4E-9E37-6A112DB83550}"/>
              </a:ext>
            </a:extLst>
          </p:cNvPr>
          <p:cNvGrpSpPr/>
          <p:nvPr/>
        </p:nvGrpSpPr>
        <p:grpSpPr>
          <a:xfrm>
            <a:off x="452762" y="206368"/>
            <a:ext cx="8005438" cy="5008570"/>
            <a:chOff x="452762" y="1649412"/>
            <a:chExt cx="7532998" cy="4510822"/>
          </a:xfrm>
        </p:grpSpPr>
        <p:graphicFrame>
          <p:nvGraphicFramePr>
            <p:cNvPr id="2" name="Chart 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75691141"/>
                </p:ext>
              </p:extLst>
            </p:nvPr>
          </p:nvGraphicFramePr>
          <p:xfrm>
            <a:off x="1584960" y="1649412"/>
            <a:ext cx="6400800" cy="355917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1700654E-0CB4-444B-A51E-7FF2BF96D95C}"/>
                </a:ext>
              </a:extLst>
            </p:cNvPr>
            <p:cNvGrpSpPr/>
            <p:nvPr/>
          </p:nvGrpSpPr>
          <p:grpSpPr>
            <a:xfrm>
              <a:off x="2415540" y="5821680"/>
              <a:ext cx="2022893" cy="338554"/>
              <a:chOff x="2392680" y="6195060"/>
              <a:chExt cx="2045753" cy="338554"/>
            </a:xfrm>
          </p:grpSpPr>
          <p:sp>
            <p:nvSpPr>
              <p:cNvPr id="3" name="TextBox 2">
                <a:extLst>
                  <a:ext uri="{FF2B5EF4-FFF2-40B4-BE49-F238E27FC236}">
                    <a16:creationId xmlns:a16="http://schemas.microsoft.com/office/drawing/2014/main" id="{AD470FF3-7F1C-6741-884E-B7915349CEE7}"/>
                  </a:ext>
                </a:extLst>
              </p:cNvPr>
              <p:cNvSpPr txBox="1"/>
              <p:nvPr/>
            </p:nvSpPr>
            <p:spPr>
              <a:xfrm>
                <a:off x="2735722" y="6195060"/>
                <a:ext cx="135966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unc-54(r293)</a:t>
                </a:r>
              </a:p>
            </p:txBody>
          </p:sp>
          <p:cxnSp>
            <p:nvCxnSpPr>
              <p:cNvPr id="6" name="Straight Connector 5">
                <a:extLst>
                  <a:ext uri="{FF2B5EF4-FFF2-40B4-BE49-F238E27FC236}">
                    <a16:creationId xmlns:a16="http://schemas.microsoft.com/office/drawing/2014/main" id="{3AD1D341-EFA6-8F46-A8BE-3DA119CAE2B5}"/>
                  </a:ext>
                </a:extLst>
              </p:cNvPr>
              <p:cNvCxnSpPr/>
              <p:nvPr/>
            </p:nvCxnSpPr>
            <p:spPr>
              <a:xfrm>
                <a:off x="2392680" y="6195060"/>
                <a:ext cx="2045753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F858B3A5-7F14-B544-89E9-6301EB4DBDAB}"/>
                </a:ext>
              </a:extLst>
            </p:cNvPr>
            <p:cNvGrpSpPr/>
            <p:nvPr/>
          </p:nvGrpSpPr>
          <p:grpSpPr>
            <a:xfrm>
              <a:off x="5745480" y="5821680"/>
              <a:ext cx="2045753" cy="338554"/>
              <a:chOff x="5745480" y="6195060"/>
              <a:chExt cx="2045753" cy="338554"/>
            </a:xfrm>
          </p:grpSpPr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D69F9412-7848-7746-B9FB-E1E98274934E}"/>
                  </a:ext>
                </a:extLst>
              </p:cNvPr>
              <p:cNvSpPr txBox="1"/>
              <p:nvPr/>
            </p:nvSpPr>
            <p:spPr>
              <a:xfrm>
                <a:off x="6088522" y="6195060"/>
                <a:ext cx="135966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unc-54(r293)</a:t>
                </a:r>
              </a:p>
            </p:txBody>
          </p:sp>
          <p:cxnSp>
            <p:nvCxnSpPr>
              <p:cNvPr id="7" name="Straight Connector 6">
                <a:extLst>
                  <a:ext uri="{FF2B5EF4-FFF2-40B4-BE49-F238E27FC236}">
                    <a16:creationId xmlns:a16="http://schemas.microsoft.com/office/drawing/2014/main" id="{F61F44AC-267B-0F44-8A03-29CD95746A89}"/>
                  </a:ext>
                </a:extLst>
              </p:cNvPr>
              <p:cNvCxnSpPr/>
              <p:nvPr/>
            </p:nvCxnSpPr>
            <p:spPr>
              <a:xfrm>
                <a:off x="5745480" y="6195060"/>
                <a:ext cx="2045753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2C9D8123-B39A-4A4E-9852-3C6657734F0C}"/>
                </a:ext>
              </a:extLst>
            </p:cNvPr>
            <p:cNvGrpSpPr/>
            <p:nvPr/>
          </p:nvGrpSpPr>
          <p:grpSpPr>
            <a:xfrm>
              <a:off x="452762" y="5015536"/>
              <a:ext cx="3890639" cy="891591"/>
              <a:chOff x="452762" y="5015536"/>
              <a:chExt cx="3890639" cy="891591"/>
            </a:xfrm>
          </p:grpSpPr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12D33953-0F82-9443-998B-73E57A5A5FAF}"/>
                  </a:ext>
                </a:extLst>
              </p:cNvPr>
              <p:cNvSpPr txBox="1"/>
              <p:nvPr/>
            </p:nvSpPr>
            <p:spPr>
              <a:xfrm>
                <a:off x="1911876" y="5102552"/>
                <a:ext cx="50366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2688245C-2A7B-B240-AF1D-6CE811DA60E4}"/>
                  </a:ext>
                </a:extLst>
              </p:cNvPr>
              <p:cNvSpPr txBox="1"/>
              <p:nvPr/>
            </p:nvSpPr>
            <p:spPr>
              <a:xfrm>
                <a:off x="452762" y="5102552"/>
                <a:ext cx="156523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i="1" dirty="0"/>
                  <a:t>smg-1</a:t>
                </a:r>
                <a:r>
                  <a:rPr lang="en-US" sz="1600" dirty="0"/>
                  <a:t> mutation: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7EF25A1A-AA4D-5845-8656-C0FBE065F42A}"/>
                  </a:ext>
                </a:extLst>
              </p:cNvPr>
              <p:cNvSpPr txBox="1"/>
              <p:nvPr/>
            </p:nvSpPr>
            <p:spPr>
              <a:xfrm rot="18638685">
                <a:off x="2350463" y="5292055"/>
                <a:ext cx="89159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c546</a:t>
                </a:r>
                <a:r>
                  <a:rPr 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ts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0E610B1A-0C62-194E-A72B-D0173C59A8C8}"/>
                  </a:ext>
                </a:extLst>
              </p:cNvPr>
              <p:cNvSpPr txBox="1"/>
              <p:nvPr/>
            </p:nvSpPr>
            <p:spPr>
              <a:xfrm>
                <a:off x="2415540" y="5094932"/>
                <a:ext cx="31931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B35C0415-B668-3F4F-93EE-EA63DBD1C439}"/>
                  </a:ext>
                </a:extLst>
              </p:cNvPr>
              <p:cNvSpPr txBox="1"/>
              <p:nvPr/>
            </p:nvSpPr>
            <p:spPr>
              <a:xfrm rot="18638685">
                <a:off x="2776338" y="5292055"/>
                <a:ext cx="89159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c545</a:t>
                </a:r>
                <a:r>
                  <a:rPr 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ts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C370C04D-0FB1-374E-806E-032AB8FD71BC}"/>
                  </a:ext>
                </a:extLst>
              </p:cNvPr>
              <p:cNvSpPr txBox="1"/>
              <p:nvPr/>
            </p:nvSpPr>
            <p:spPr>
              <a:xfrm rot="18638685">
                <a:off x="3512842" y="5166849"/>
                <a:ext cx="48122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re1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F357B4C8-A62F-ED42-88DA-701C68CC3112}"/>
                  </a:ext>
                </a:extLst>
              </p:cNvPr>
              <p:cNvSpPr txBox="1"/>
              <p:nvPr/>
            </p:nvSpPr>
            <p:spPr>
              <a:xfrm rot="18638685">
                <a:off x="3876606" y="5210027"/>
                <a:ext cx="59503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r861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4" name="Group 23">
              <a:extLst>
                <a:ext uri="{FF2B5EF4-FFF2-40B4-BE49-F238E27FC236}">
                  <a16:creationId xmlns:a16="http://schemas.microsoft.com/office/drawing/2014/main" id="{83D9EE90-A1F9-9447-A443-135100A3A433}"/>
                </a:ext>
              </a:extLst>
            </p:cNvPr>
            <p:cNvGrpSpPr/>
            <p:nvPr/>
          </p:nvGrpSpPr>
          <p:grpSpPr>
            <a:xfrm>
              <a:off x="5264675" y="5015536"/>
              <a:ext cx="2469544" cy="891591"/>
              <a:chOff x="5264675" y="5015536"/>
              <a:chExt cx="2469544" cy="891591"/>
            </a:xfrm>
          </p:grpSpPr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5F90D045-B5B3-2144-B540-A7A889220B4A}"/>
                  </a:ext>
                </a:extLst>
              </p:cNvPr>
              <p:cNvSpPr txBox="1"/>
              <p:nvPr/>
            </p:nvSpPr>
            <p:spPr>
              <a:xfrm>
                <a:off x="5264675" y="5102552"/>
                <a:ext cx="50366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CAF15627-BA30-2448-A302-1FB1168E9EA8}"/>
                  </a:ext>
                </a:extLst>
              </p:cNvPr>
              <p:cNvSpPr txBox="1"/>
              <p:nvPr/>
            </p:nvSpPr>
            <p:spPr>
              <a:xfrm rot="18638685">
                <a:off x="5741281" y="5292055"/>
                <a:ext cx="89159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c546</a:t>
                </a:r>
                <a:r>
                  <a:rPr 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ts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AA1DB2B7-C192-4F4B-8D71-E3E168C9BE88}"/>
                  </a:ext>
                </a:extLst>
              </p:cNvPr>
              <p:cNvSpPr txBox="1"/>
              <p:nvPr/>
            </p:nvSpPr>
            <p:spPr>
              <a:xfrm>
                <a:off x="5806358" y="5094932"/>
                <a:ext cx="31931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A5B249D7-98E4-AD42-95E4-B807A19FA064}"/>
                  </a:ext>
                </a:extLst>
              </p:cNvPr>
              <p:cNvSpPr txBox="1"/>
              <p:nvPr/>
            </p:nvSpPr>
            <p:spPr>
              <a:xfrm rot="18638685">
                <a:off x="6167156" y="5292055"/>
                <a:ext cx="89159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c545</a:t>
                </a:r>
                <a:r>
                  <a:rPr 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ts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AEA1CEF8-EFFE-BB46-B961-9D89E7E3B606}"/>
                  </a:ext>
                </a:extLst>
              </p:cNvPr>
              <p:cNvSpPr txBox="1"/>
              <p:nvPr/>
            </p:nvSpPr>
            <p:spPr>
              <a:xfrm rot="18638685">
                <a:off x="6903660" y="5166849"/>
                <a:ext cx="48122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re1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98678355-2CBB-1347-BEF4-42FC95A1C13F}"/>
                  </a:ext>
                </a:extLst>
              </p:cNvPr>
              <p:cNvSpPr txBox="1"/>
              <p:nvPr/>
            </p:nvSpPr>
            <p:spPr>
              <a:xfrm rot="18638685">
                <a:off x="7267424" y="5210027"/>
                <a:ext cx="59503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r861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8C28EAB9-10AE-A045-A0C8-165C1D7EC1E7}"/>
                </a:ext>
              </a:extLst>
            </p:cNvPr>
            <p:cNvSpPr txBox="1"/>
            <p:nvPr/>
          </p:nvSpPr>
          <p:spPr>
            <a:xfrm>
              <a:off x="2939042" y="2136467"/>
              <a:ext cx="66236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/>
                <a:t>15˚C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9A98B52B-C5FB-4840-B28E-DB2D96C896D8}"/>
                </a:ext>
              </a:extLst>
            </p:cNvPr>
            <p:cNvSpPr txBox="1"/>
            <p:nvPr/>
          </p:nvSpPr>
          <p:spPr>
            <a:xfrm>
              <a:off x="6437175" y="2136467"/>
              <a:ext cx="66236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/>
                <a:t>25˚C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F4795F2E-8981-2849-80E9-12554198FAFD}"/>
                </a:ext>
              </a:extLst>
            </p:cNvPr>
            <p:cNvSpPr txBox="1"/>
            <p:nvPr/>
          </p:nvSpPr>
          <p:spPr>
            <a:xfrm rot="16200000">
              <a:off x="232667" y="3410912"/>
              <a:ext cx="270458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Radial distance travelled (mm)</a:t>
              </a:r>
            </a:p>
          </p:txBody>
        </p:sp>
        <p:cxnSp>
          <p:nvCxnSpPr>
            <p:cNvPr id="30" name="Straight Connector 29">
              <a:extLst>
                <a:ext uri="{FF2B5EF4-FFF2-40B4-BE49-F238E27FC236}">
                  <a16:creationId xmlns:a16="http://schemas.microsoft.com/office/drawing/2014/main" id="{B839B6F1-53CF-6644-B7C4-9AA32442CA2F}"/>
                </a:ext>
              </a:extLst>
            </p:cNvPr>
            <p:cNvCxnSpPr/>
            <p:nvPr/>
          </p:nvCxnSpPr>
          <p:spPr>
            <a:xfrm flipV="1">
              <a:off x="2803314" y="4191660"/>
              <a:ext cx="764251" cy="360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id="{7A524F28-D0D4-3645-BACB-CE180AA0C0E1}"/>
                </a:ext>
              </a:extLst>
            </p:cNvPr>
            <p:cNvCxnSpPr/>
            <p:nvPr/>
          </p:nvCxnSpPr>
          <p:spPr>
            <a:xfrm>
              <a:off x="3798113" y="3302660"/>
              <a:ext cx="473231" cy="1588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42AA8F55-7710-DF4B-89AB-3928DB7A78F1}"/>
                </a:ext>
              </a:extLst>
            </p:cNvPr>
            <p:cNvCxnSpPr/>
            <p:nvPr/>
          </p:nvCxnSpPr>
          <p:spPr>
            <a:xfrm rot="16200000" flipH="1">
              <a:off x="2550439" y="3544243"/>
              <a:ext cx="1270000" cy="12134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id="{A74F4D41-29A5-A447-9015-8F6C19B655C4}"/>
                </a:ext>
              </a:extLst>
            </p:cNvPr>
            <p:cNvCxnSpPr/>
            <p:nvPr/>
          </p:nvCxnSpPr>
          <p:spPr>
            <a:xfrm rot="16200000" flipH="1">
              <a:off x="3847405" y="3099652"/>
              <a:ext cx="374650" cy="5966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id="{B8698A36-012B-1E4C-A3AA-79744C40F375}"/>
                </a:ext>
              </a:extLst>
            </p:cNvPr>
            <p:cNvCxnSpPr/>
            <p:nvPr/>
          </p:nvCxnSpPr>
          <p:spPr>
            <a:xfrm>
              <a:off x="3167138" y="2919542"/>
              <a:ext cx="865570" cy="635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6026260D-AECE-C942-9AF4-4FEF2AA720F7}"/>
                </a:ext>
              </a:extLst>
            </p:cNvPr>
            <p:cNvSpPr txBox="1"/>
            <p:nvPr/>
          </p:nvSpPr>
          <p:spPr>
            <a:xfrm>
              <a:off x="3184033" y="2654946"/>
              <a:ext cx="84394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 &lt; 0.003</a:t>
              </a:r>
            </a:p>
          </p:txBody>
        </p:sp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E7A4A97C-7184-BD41-8FA2-F24447EB5690}"/>
                </a:ext>
              </a:extLst>
            </p:cNvPr>
            <p:cNvCxnSpPr/>
            <p:nvPr/>
          </p:nvCxnSpPr>
          <p:spPr>
            <a:xfrm>
              <a:off x="6303506" y="3035418"/>
              <a:ext cx="1487726" cy="1588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E8356B91-9B69-ED47-9B0B-36FCC13F7525}"/>
                </a:ext>
              </a:extLst>
            </p:cNvPr>
            <p:cNvCxnSpPr/>
            <p:nvPr/>
          </p:nvCxnSpPr>
          <p:spPr>
            <a:xfrm rot="16200000" flipH="1">
              <a:off x="5425155" y="3191398"/>
              <a:ext cx="1051983" cy="10196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>
              <a:extLst>
                <a:ext uri="{FF2B5EF4-FFF2-40B4-BE49-F238E27FC236}">
                  <a16:creationId xmlns:a16="http://schemas.microsoft.com/office/drawing/2014/main" id="{378E31EB-124A-C241-A81E-7C4EAA518630}"/>
                </a:ext>
              </a:extLst>
            </p:cNvPr>
            <p:cNvCxnSpPr/>
            <p:nvPr/>
          </p:nvCxnSpPr>
          <p:spPr>
            <a:xfrm rot="16200000" flipH="1">
              <a:off x="6867664" y="2848598"/>
              <a:ext cx="374650" cy="7426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Connector 39">
              <a:extLst>
                <a:ext uri="{FF2B5EF4-FFF2-40B4-BE49-F238E27FC236}">
                  <a16:creationId xmlns:a16="http://schemas.microsoft.com/office/drawing/2014/main" id="{711987BA-C87D-E949-94EF-821EB1CA08EF}"/>
                </a:ext>
              </a:extLst>
            </p:cNvPr>
            <p:cNvCxnSpPr/>
            <p:nvPr/>
          </p:nvCxnSpPr>
          <p:spPr>
            <a:xfrm>
              <a:off x="5935979" y="2673466"/>
              <a:ext cx="1122717" cy="2118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4EA3D595-7618-0246-B86A-3D9A0A162A39}"/>
                </a:ext>
              </a:extLst>
            </p:cNvPr>
            <p:cNvSpPr txBox="1"/>
            <p:nvPr/>
          </p:nvSpPr>
          <p:spPr>
            <a:xfrm>
              <a:off x="6107253" y="2408107"/>
              <a:ext cx="90974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 &lt; 0.001</a:t>
              </a:r>
            </a:p>
          </p:txBody>
        </p:sp>
      </p:grpSp>
      <p:sp>
        <p:nvSpPr>
          <p:cNvPr id="43" name="TextBox 42">
            <a:extLst>
              <a:ext uri="{FF2B5EF4-FFF2-40B4-BE49-F238E27FC236}">
                <a16:creationId xmlns:a16="http://schemas.microsoft.com/office/drawing/2014/main" id="{67AED11E-2D30-B24E-829B-8E746E3D8052}"/>
              </a:ext>
            </a:extLst>
          </p:cNvPr>
          <p:cNvSpPr txBox="1"/>
          <p:nvPr/>
        </p:nvSpPr>
        <p:spPr>
          <a:xfrm>
            <a:off x="-67037" y="-12678"/>
            <a:ext cx="2044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>
                <a:latin typeface="Arial"/>
                <a:cs typeface="Arial"/>
              </a:rPr>
              <a:t>Pedone Figure </a:t>
            </a:r>
            <a:r>
              <a:rPr lang="en-US" dirty="0">
                <a:latin typeface="Arial"/>
                <a:cs typeface="Arial"/>
              </a:rPr>
              <a:t>S5</a:t>
            </a:r>
          </a:p>
        </p:txBody>
      </p:sp>
    </p:spTree>
    <p:extLst>
      <p:ext uri="{BB962C8B-B14F-4D97-AF65-F5344CB8AC3E}">
        <p14:creationId xmlns:p14="http://schemas.microsoft.com/office/powerpoint/2010/main" val="20251139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8937</TotalTime>
  <Words>45</Words>
  <Application>Microsoft Macintosh PowerPoint</Application>
  <PresentationFormat>On-screen Show (4:3)</PresentationFormat>
  <Paragraphs>2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Texas A&amp;M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e Reiner</dc:creator>
  <cp:lastModifiedBy>Microsoft Office User</cp:lastModifiedBy>
  <cp:revision>395</cp:revision>
  <cp:lastPrinted>2021-02-03T22:42:10Z</cp:lastPrinted>
  <dcterms:created xsi:type="dcterms:W3CDTF">2015-07-16T15:46:30Z</dcterms:created>
  <dcterms:modified xsi:type="dcterms:W3CDTF">2021-07-02T21:41:26Z</dcterms:modified>
</cp:coreProperties>
</file>